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0" d="100"/>
          <a:sy n="120" d="100"/>
        </p:scale>
        <p:origin x="2184" y="-30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063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246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885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159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08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918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913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566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953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22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557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552ED2-CAC7-4D14-8EDC-82E09BFC0F0A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C13F2C-7424-4B0D-A030-761D015E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873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DEC3774-1A30-4A83-89BD-7D83A635BC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2954" y="1090400"/>
            <a:ext cx="6268065" cy="381205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8AF880A-8048-4898-82A3-4086EDDBA03F}"/>
              </a:ext>
            </a:extLst>
          </p:cNvPr>
          <p:cNvSpPr txBox="1"/>
          <p:nvPr/>
        </p:nvSpPr>
        <p:spPr>
          <a:xfrm rot="16200000">
            <a:off x="-261590" y="4330892"/>
            <a:ext cx="1133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800" dirty="0" err="1"/>
              <a:t>Extreme</a:t>
            </a:r>
            <a:r>
              <a:rPr lang="et-EE" sz="800" dirty="0"/>
              <a:t> </a:t>
            </a:r>
            <a:r>
              <a:rPr lang="et-EE" sz="800" dirty="0" err="1"/>
              <a:t>rainfall</a:t>
            </a:r>
            <a:r>
              <a:rPr lang="et-EE" sz="800" dirty="0"/>
              <a:t> </a:t>
            </a:r>
            <a:r>
              <a:rPr lang="et-EE" sz="800" dirty="0" err="1"/>
              <a:t>deficit</a:t>
            </a:r>
            <a:endParaRPr lang="en-US" sz="8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04EE211-00FE-4FC6-9844-A90C53D196EC}"/>
              </a:ext>
            </a:extLst>
          </p:cNvPr>
          <p:cNvSpPr txBox="1"/>
          <p:nvPr/>
        </p:nvSpPr>
        <p:spPr>
          <a:xfrm rot="16200000">
            <a:off x="-54802" y="1403595"/>
            <a:ext cx="7200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800" dirty="0" err="1"/>
              <a:t>Water</a:t>
            </a:r>
            <a:r>
              <a:rPr lang="et-EE" sz="800" dirty="0"/>
              <a:t> </a:t>
            </a:r>
            <a:r>
              <a:rPr lang="et-EE" sz="800" dirty="0" err="1"/>
              <a:t>status</a:t>
            </a:r>
            <a:endParaRPr lang="en-US" sz="8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8F9C3E8-76D1-4365-B04F-D262EFE4F309}"/>
              </a:ext>
            </a:extLst>
          </p:cNvPr>
          <p:cNvSpPr txBox="1"/>
          <p:nvPr/>
        </p:nvSpPr>
        <p:spPr>
          <a:xfrm rot="16200000">
            <a:off x="3202984" y="1403595"/>
            <a:ext cx="6880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800" dirty="0" err="1"/>
              <a:t>Humus</a:t>
            </a:r>
            <a:r>
              <a:rPr lang="et-EE" sz="800" dirty="0"/>
              <a:t> </a:t>
            </a:r>
            <a:r>
              <a:rPr lang="et-EE" sz="800" dirty="0" err="1"/>
              <a:t>type</a:t>
            </a:r>
            <a:endParaRPr lang="en-US" sz="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BF9DAB7-8952-4F5F-8A48-8DC48E111D16}"/>
              </a:ext>
            </a:extLst>
          </p:cNvPr>
          <p:cNvSpPr txBox="1"/>
          <p:nvPr/>
        </p:nvSpPr>
        <p:spPr>
          <a:xfrm rot="16200000">
            <a:off x="-27549" y="2377157"/>
            <a:ext cx="6655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800" dirty="0" err="1"/>
              <a:t>Ash</a:t>
            </a:r>
            <a:r>
              <a:rPr lang="et-EE" sz="800" dirty="0"/>
              <a:t> </a:t>
            </a:r>
            <a:r>
              <a:rPr lang="et-EE" sz="800" dirty="0" err="1"/>
              <a:t>density</a:t>
            </a:r>
            <a:endParaRPr lang="en-US" sz="8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EB5A01D-53F7-4F39-BF72-D37EC8D20B10}"/>
              </a:ext>
            </a:extLst>
          </p:cNvPr>
          <p:cNvSpPr txBox="1"/>
          <p:nvPr/>
        </p:nvSpPr>
        <p:spPr>
          <a:xfrm rot="16200000">
            <a:off x="3210275" y="2447758"/>
            <a:ext cx="7328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800" dirty="0" err="1"/>
              <a:t>Max.Temp</a:t>
            </a:r>
            <a:r>
              <a:rPr lang="et-EE" sz="800" dirty="0"/>
              <a:t>&gt;0</a:t>
            </a:r>
            <a:endParaRPr lang="en-US" sz="8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2841F4-FE3E-41AC-9BD6-2F6323178757}"/>
              </a:ext>
            </a:extLst>
          </p:cNvPr>
          <p:cNvSpPr txBox="1"/>
          <p:nvPr/>
        </p:nvSpPr>
        <p:spPr>
          <a:xfrm rot="16200000">
            <a:off x="-61215" y="3282762"/>
            <a:ext cx="7328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800" dirty="0" err="1"/>
              <a:t>Max.Temp</a:t>
            </a:r>
            <a:r>
              <a:rPr lang="et-EE" sz="800" dirty="0"/>
              <a:t>&lt;0</a:t>
            </a:r>
            <a:endParaRPr lang="en-US" sz="8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7DAA53E-9106-4D30-B0E8-E478CCDF086F}"/>
              </a:ext>
            </a:extLst>
          </p:cNvPr>
          <p:cNvSpPr txBox="1"/>
          <p:nvPr/>
        </p:nvSpPr>
        <p:spPr>
          <a:xfrm rot="16200000">
            <a:off x="2989859" y="3346016"/>
            <a:ext cx="11737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800" dirty="0" err="1"/>
              <a:t>Extreme</a:t>
            </a:r>
            <a:r>
              <a:rPr lang="et-EE" sz="800" dirty="0"/>
              <a:t> </a:t>
            </a:r>
            <a:r>
              <a:rPr lang="et-EE" sz="800" dirty="0" err="1"/>
              <a:t>rainfall</a:t>
            </a:r>
            <a:r>
              <a:rPr lang="et-EE" sz="800" dirty="0"/>
              <a:t> </a:t>
            </a:r>
            <a:r>
              <a:rPr lang="et-EE" sz="800" dirty="0" err="1"/>
              <a:t>surplus</a:t>
            </a:r>
            <a:endParaRPr lang="en-US" sz="8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D1FE746-7F51-494A-9297-C23C9643F261}"/>
              </a:ext>
            </a:extLst>
          </p:cNvPr>
          <p:cNvSpPr txBox="1"/>
          <p:nvPr/>
        </p:nvSpPr>
        <p:spPr>
          <a:xfrm>
            <a:off x="896753" y="595519"/>
            <a:ext cx="5359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 err="1"/>
              <a:t>Tests</a:t>
            </a:r>
            <a:r>
              <a:rPr lang="et-EE" dirty="0"/>
              <a:t> </a:t>
            </a:r>
            <a:r>
              <a:rPr lang="et-EE" dirty="0" err="1"/>
              <a:t>for</a:t>
            </a:r>
            <a:r>
              <a:rPr lang="et-EE" dirty="0"/>
              <a:t> </a:t>
            </a:r>
            <a:r>
              <a:rPr lang="et-EE" dirty="0" err="1"/>
              <a:t>zero</a:t>
            </a:r>
            <a:r>
              <a:rPr lang="et-EE" dirty="0"/>
              <a:t> </a:t>
            </a:r>
            <a:r>
              <a:rPr lang="et-EE" dirty="0" err="1"/>
              <a:t>slope</a:t>
            </a:r>
            <a:r>
              <a:rPr lang="et-EE" dirty="0"/>
              <a:t> </a:t>
            </a:r>
            <a:r>
              <a:rPr lang="et-EE" dirty="0" err="1"/>
              <a:t>for</a:t>
            </a:r>
            <a:r>
              <a:rPr lang="et-EE" dirty="0"/>
              <a:t> Cox-</a:t>
            </a:r>
            <a:r>
              <a:rPr lang="et-EE" dirty="0" err="1"/>
              <a:t>proportional</a:t>
            </a:r>
            <a:r>
              <a:rPr lang="et-EE" dirty="0"/>
              <a:t> </a:t>
            </a:r>
            <a:r>
              <a:rPr lang="et-EE" dirty="0" err="1"/>
              <a:t>hazard</a:t>
            </a:r>
            <a:r>
              <a:rPr lang="et-EE" dirty="0"/>
              <a:t> </a:t>
            </a:r>
            <a:r>
              <a:rPr lang="et-EE" dirty="0" err="1"/>
              <a:t>models</a:t>
            </a:r>
            <a:endParaRPr lang="en-US" dirty="0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E3DCDD59-AE73-41F4-BF35-04753D3D4AD4}"/>
              </a:ext>
            </a:extLst>
          </p:cNvPr>
          <p:cNvGrpSpPr/>
          <p:nvPr/>
        </p:nvGrpSpPr>
        <p:grpSpPr>
          <a:xfrm>
            <a:off x="146427" y="6653485"/>
            <a:ext cx="6585678" cy="4018004"/>
            <a:chOff x="136161" y="5914014"/>
            <a:chExt cx="6585678" cy="4018004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79027E67-8EDD-4217-9169-E2D9E6472D1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2133" y="5914014"/>
              <a:ext cx="6349706" cy="3912488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53AE13E-ED59-4958-9726-6649D3027A4F}"/>
                </a:ext>
              </a:extLst>
            </p:cNvPr>
            <p:cNvSpPr txBox="1"/>
            <p:nvPr/>
          </p:nvSpPr>
          <p:spPr>
            <a:xfrm rot="16200000">
              <a:off x="3009895" y="9217400"/>
              <a:ext cx="1133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t-EE" sz="800" dirty="0" err="1"/>
                <a:t>Extreme</a:t>
              </a:r>
              <a:r>
                <a:rPr lang="et-EE" sz="800" dirty="0"/>
                <a:t> </a:t>
              </a:r>
              <a:r>
                <a:rPr lang="et-EE" sz="800" dirty="0" err="1"/>
                <a:t>rainfall</a:t>
              </a:r>
              <a:r>
                <a:rPr lang="et-EE" sz="800" dirty="0"/>
                <a:t> </a:t>
              </a:r>
              <a:r>
                <a:rPr lang="et-EE" sz="800" dirty="0" err="1"/>
                <a:t>deficit</a:t>
              </a:r>
              <a:endParaRPr lang="en-US" sz="8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827645C-3E0C-4ED7-9683-3199E639DB32}"/>
                </a:ext>
              </a:extLst>
            </p:cNvPr>
            <p:cNvSpPr txBox="1"/>
            <p:nvPr/>
          </p:nvSpPr>
          <p:spPr>
            <a:xfrm rot="16200000">
              <a:off x="-342977" y="9237437"/>
              <a:ext cx="117371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t-EE" sz="800" dirty="0" err="1"/>
                <a:t>Extreme</a:t>
              </a:r>
              <a:r>
                <a:rPr lang="et-EE" sz="800" dirty="0"/>
                <a:t> </a:t>
              </a:r>
              <a:r>
                <a:rPr lang="et-EE" sz="800" dirty="0" err="1"/>
                <a:t>rainfall</a:t>
              </a:r>
              <a:r>
                <a:rPr lang="et-EE" sz="800" dirty="0"/>
                <a:t> </a:t>
              </a:r>
              <a:r>
                <a:rPr lang="et-EE" sz="800" dirty="0" err="1"/>
                <a:t>surplus</a:t>
              </a:r>
              <a:endParaRPr lang="en-US" sz="8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E01DA4B-C0F1-4E64-9A42-7881539F7EB2}"/>
                </a:ext>
              </a:extLst>
            </p:cNvPr>
            <p:cNvSpPr txBox="1"/>
            <p:nvPr/>
          </p:nvSpPr>
          <p:spPr>
            <a:xfrm rot="16200000">
              <a:off x="3191478" y="8218689"/>
              <a:ext cx="7328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t-EE" sz="800" dirty="0" err="1"/>
                <a:t>Max.Temp</a:t>
              </a:r>
              <a:r>
                <a:rPr lang="et-EE" sz="800" dirty="0"/>
                <a:t>&lt;0</a:t>
              </a:r>
              <a:endParaRPr lang="en-US" sz="8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9F2D849-3E8B-4C93-B3CA-63899304AF6A}"/>
                </a:ext>
              </a:extLst>
            </p:cNvPr>
            <p:cNvSpPr txBox="1"/>
            <p:nvPr/>
          </p:nvSpPr>
          <p:spPr>
            <a:xfrm rot="16200000">
              <a:off x="-61215" y="8238390"/>
              <a:ext cx="7328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t-EE" sz="800" dirty="0" err="1"/>
                <a:t>Max.Temp</a:t>
              </a:r>
              <a:r>
                <a:rPr lang="et-EE" sz="800" dirty="0"/>
                <a:t>&gt;0</a:t>
              </a:r>
              <a:endParaRPr lang="en-US" sz="8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4D3CB7D-B3F2-4D95-BD7B-CE97377CF950}"/>
                </a:ext>
              </a:extLst>
            </p:cNvPr>
            <p:cNvSpPr txBox="1"/>
            <p:nvPr/>
          </p:nvSpPr>
          <p:spPr>
            <a:xfrm rot="16200000">
              <a:off x="3201050" y="7228435"/>
              <a:ext cx="6655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t-EE" sz="800" dirty="0" err="1"/>
                <a:t>Ash</a:t>
              </a:r>
              <a:r>
                <a:rPr lang="et-EE" sz="800" dirty="0"/>
                <a:t> </a:t>
              </a:r>
              <a:r>
                <a:rPr lang="et-EE" sz="800" dirty="0" err="1"/>
                <a:t>density</a:t>
              </a:r>
              <a:endParaRPr lang="en-US" sz="8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5A8751B-8175-42C3-922A-62275DB6FE9E}"/>
                </a:ext>
              </a:extLst>
            </p:cNvPr>
            <p:cNvSpPr txBox="1"/>
            <p:nvPr/>
          </p:nvSpPr>
          <p:spPr>
            <a:xfrm rot="16200000">
              <a:off x="-26068" y="7271523"/>
              <a:ext cx="6880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t-EE" sz="800" dirty="0" err="1"/>
                <a:t>Humus</a:t>
              </a:r>
              <a:r>
                <a:rPr lang="et-EE" sz="800" dirty="0"/>
                <a:t> </a:t>
              </a:r>
              <a:r>
                <a:rPr lang="et-EE" sz="800" dirty="0" err="1"/>
                <a:t>type</a:t>
              </a:r>
              <a:endParaRPr lang="en-US" sz="8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371CD64-EC5D-46D0-AC6A-FCF117B7D093}"/>
                </a:ext>
              </a:extLst>
            </p:cNvPr>
            <p:cNvSpPr txBox="1"/>
            <p:nvPr/>
          </p:nvSpPr>
          <p:spPr>
            <a:xfrm rot="16200000">
              <a:off x="3173798" y="6237006"/>
              <a:ext cx="720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t-EE" sz="800" dirty="0" err="1"/>
                <a:t>Water</a:t>
              </a:r>
              <a:r>
                <a:rPr lang="et-EE" sz="800" dirty="0"/>
                <a:t> </a:t>
              </a:r>
              <a:r>
                <a:rPr lang="et-EE" sz="800" dirty="0" err="1"/>
                <a:t>status</a:t>
              </a:r>
              <a:endParaRPr lang="en-US" sz="8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69EEDE8-E3F3-4C3B-871A-CD9D023D34AE}"/>
                </a:ext>
              </a:extLst>
            </p:cNvPr>
            <p:cNvSpPr txBox="1"/>
            <p:nvPr/>
          </p:nvSpPr>
          <p:spPr>
            <a:xfrm rot="16200000">
              <a:off x="34045" y="6237006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t-EE" sz="800" dirty="0" err="1"/>
                <a:t>Intercept</a:t>
              </a:r>
              <a:endParaRPr lang="en-US" sz="800" dirty="0"/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DD01ADFE-8D45-4FFC-9AEB-C8E9A002CC44}"/>
              </a:ext>
            </a:extLst>
          </p:cNvPr>
          <p:cNvSpPr txBox="1"/>
          <p:nvPr/>
        </p:nvSpPr>
        <p:spPr>
          <a:xfrm>
            <a:off x="1300983" y="5564220"/>
            <a:ext cx="457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stimated cumulative regression functions with 95% pointwise confidence intervals based on Aalen’s additive model</a:t>
            </a:r>
          </a:p>
        </p:txBody>
      </p:sp>
    </p:spTree>
    <p:extLst>
      <p:ext uri="{BB962C8B-B14F-4D97-AF65-F5344CB8AC3E}">
        <p14:creationId xmlns:p14="http://schemas.microsoft.com/office/powerpoint/2010/main" val="4073928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68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 Peter George</dc:creator>
  <cp:lastModifiedBy>Jan Peter George</cp:lastModifiedBy>
  <cp:revision>2</cp:revision>
  <dcterms:created xsi:type="dcterms:W3CDTF">2021-05-20T13:50:59Z</dcterms:created>
  <dcterms:modified xsi:type="dcterms:W3CDTF">2021-05-20T14:07:38Z</dcterms:modified>
</cp:coreProperties>
</file>